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60" r:id="rId1"/>
  </p:sldMasterIdLst>
  <p:notesMasterIdLst>
    <p:notesMasterId r:id="rId3"/>
  </p:notesMasterIdLst>
  <p:sldIdLst>
    <p:sldId id="308" r:id="rId2"/>
  </p:sldIdLst>
  <p:sldSz cx="11112500" cy="18018125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75">
          <p15:clr>
            <a:srgbClr val="A4A3A4"/>
          </p15:clr>
        </p15:guide>
        <p15:guide id="2" pos="350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000"/>
    <a:srgbClr val="0000FF"/>
    <a:srgbClr val="006600"/>
    <a:srgbClr val="F808E7"/>
    <a:srgbClr val="E2DD05"/>
    <a:srgbClr val="F7F7F7"/>
    <a:srgbClr val="9900CC"/>
    <a:srgbClr val="58267E"/>
    <a:srgbClr val="612A8A"/>
    <a:srgbClr val="632B8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Ênfas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647" autoAdjust="0"/>
    <p:restoredTop sz="92819" autoAdjust="0"/>
  </p:normalViewPr>
  <p:slideViewPr>
    <p:cSldViewPr snapToGrid="0">
      <p:cViewPr>
        <p:scale>
          <a:sx n="100" d="100"/>
          <a:sy n="100" d="100"/>
        </p:scale>
        <p:origin x="466" y="-346"/>
      </p:cViewPr>
      <p:guideLst>
        <p:guide orient="horz" pos="5675"/>
        <p:guide pos="350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8B07D4-269A-4257-AE90-362DC755ED1C}" type="datetimeFigureOut">
              <a:rPr lang="pt-BR" smtClean="0"/>
              <a:t>08/08/2022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2478088" y="1143000"/>
            <a:ext cx="19018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BR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0620742-98BB-4534-8126-31E6E2FB1523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523293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BR" dirty="0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0620742-98BB-4534-8126-31E6E2FB1523}" type="slidenum">
              <a:rPr lang="pt-BR" smtClean="0"/>
              <a:t>1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828501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33438" y="2948801"/>
            <a:ext cx="9445625" cy="6272977"/>
          </a:xfrm>
        </p:spPr>
        <p:txBody>
          <a:bodyPr anchor="b"/>
          <a:lstStyle>
            <a:lvl1pPr algn="ctr">
              <a:defRPr sz="7292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89063" y="9463688"/>
            <a:ext cx="8334375" cy="4350208"/>
          </a:xfrm>
        </p:spPr>
        <p:txBody>
          <a:bodyPr/>
          <a:lstStyle>
            <a:lvl1pPr marL="0" indent="0" algn="ctr">
              <a:buNone/>
              <a:defRPr sz="2917"/>
            </a:lvl1pPr>
            <a:lvl2pPr marL="555635" indent="0" algn="ctr">
              <a:buNone/>
              <a:defRPr sz="2431"/>
            </a:lvl2pPr>
            <a:lvl3pPr marL="1111270" indent="0" algn="ctr">
              <a:buNone/>
              <a:defRPr sz="2188"/>
            </a:lvl3pPr>
            <a:lvl4pPr marL="1666905" indent="0" algn="ctr">
              <a:buNone/>
              <a:defRPr sz="1944"/>
            </a:lvl4pPr>
            <a:lvl5pPr marL="2222541" indent="0" algn="ctr">
              <a:buNone/>
              <a:defRPr sz="1944"/>
            </a:lvl5pPr>
            <a:lvl6pPr marL="2778176" indent="0" algn="ctr">
              <a:buNone/>
              <a:defRPr sz="1944"/>
            </a:lvl6pPr>
            <a:lvl7pPr marL="3333811" indent="0" algn="ctr">
              <a:buNone/>
              <a:defRPr sz="1944"/>
            </a:lvl7pPr>
            <a:lvl8pPr marL="3889446" indent="0" algn="ctr">
              <a:buNone/>
              <a:defRPr sz="1944"/>
            </a:lvl8pPr>
            <a:lvl9pPr marL="4445081" indent="0" algn="ctr">
              <a:buNone/>
              <a:defRPr sz="1944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5F8038-DA31-49FF-8515-7C916076E055}" type="datetimeFigureOut">
              <a:rPr lang="pt-BR" smtClean="0"/>
              <a:t>08/08/2022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BB10C-BE55-4C89-ADC7-1070F8C793A9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333158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5F8038-DA31-49FF-8515-7C916076E055}" type="datetimeFigureOut">
              <a:rPr lang="pt-BR" smtClean="0"/>
              <a:t>08/08/2022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BB10C-BE55-4C89-ADC7-1070F8C793A9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73655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952383" y="959298"/>
            <a:ext cx="2396133" cy="1526952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63985" y="959298"/>
            <a:ext cx="7049492" cy="15269528"/>
          </a:xfrm>
        </p:spPr>
        <p:txBody>
          <a:bodyPr vert="eaVert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5F8038-DA31-49FF-8515-7C916076E055}" type="datetimeFigureOut">
              <a:rPr lang="pt-BR" smtClean="0"/>
              <a:t>08/08/2022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BB10C-BE55-4C89-ADC7-1070F8C793A9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03236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5F8038-DA31-49FF-8515-7C916076E055}" type="datetimeFigureOut">
              <a:rPr lang="pt-BR" smtClean="0"/>
              <a:t>08/08/2022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BB10C-BE55-4C89-ADC7-1070F8C793A9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793058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8197" y="4492024"/>
            <a:ext cx="9584531" cy="7495038"/>
          </a:xfrm>
        </p:spPr>
        <p:txBody>
          <a:bodyPr anchor="b"/>
          <a:lstStyle>
            <a:lvl1pPr>
              <a:defRPr sz="7292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8197" y="12057968"/>
            <a:ext cx="9584531" cy="3941464"/>
          </a:xfrm>
        </p:spPr>
        <p:txBody>
          <a:bodyPr/>
          <a:lstStyle>
            <a:lvl1pPr marL="0" indent="0">
              <a:buNone/>
              <a:defRPr sz="2917">
                <a:solidFill>
                  <a:schemeClr val="tx1"/>
                </a:solidFill>
              </a:defRPr>
            </a:lvl1pPr>
            <a:lvl2pPr marL="555635" indent="0">
              <a:buNone/>
              <a:defRPr sz="2431">
                <a:solidFill>
                  <a:schemeClr val="tx1">
                    <a:tint val="75000"/>
                  </a:schemeClr>
                </a:solidFill>
              </a:defRPr>
            </a:lvl2pPr>
            <a:lvl3pPr marL="1111270" indent="0">
              <a:buNone/>
              <a:defRPr sz="2188">
                <a:solidFill>
                  <a:schemeClr val="tx1">
                    <a:tint val="75000"/>
                  </a:schemeClr>
                </a:solidFill>
              </a:defRPr>
            </a:lvl3pPr>
            <a:lvl4pPr marL="1666905" indent="0">
              <a:buNone/>
              <a:defRPr sz="1944">
                <a:solidFill>
                  <a:schemeClr val="tx1">
                    <a:tint val="75000"/>
                  </a:schemeClr>
                </a:solidFill>
              </a:defRPr>
            </a:lvl4pPr>
            <a:lvl5pPr marL="2222541" indent="0">
              <a:buNone/>
              <a:defRPr sz="1944">
                <a:solidFill>
                  <a:schemeClr val="tx1">
                    <a:tint val="75000"/>
                  </a:schemeClr>
                </a:solidFill>
              </a:defRPr>
            </a:lvl5pPr>
            <a:lvl6pPr marL="2778176" indent="0">
              <a:buNone/>
              <a:defRPr sz="1944">
                <a:solidFill>
                  <a:schemeClr val="tx1">
                    <a:tint val="75000"/>
                  </a:schemeClr>
                </a:solidFill>
              </a:defRPr>
            </a:lvl6pPr>
            <a:lvl7pPr marL="3333811" indent="0">
              <a:buNone/>
              <a:defRPr sz="1944">
                <a:solidFill>
                  <a:schemeClr val="tx1">
                    <a:tint val="75000"/>
                  </a:schemeClr>
                </a:solidFill>
              </a:defRPr>
            </a:lvl7pPr>
            <a:lvl8pPr marL="3889446" indent="0">
              <a:buNone/>
              <a:defRPr sz="1944">
                <a:solidFill>
                  <a:schemeClr val="tx1">
                    <a:tint val="75000"/>
                  </a:schemeClr>
                </a:solidFill>
              </a:defRPr>
            </a:lvl8pPr>
            <a:lvl9pPr marL="4445081" indent="0">
              <a:buNone/>
              <a:defRPr sz="19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5F8038-DA31-49FF-8515-7C916076E055}" type="datetimeFigureOut">
              <a:rPr lang="pt-BR" smtClean="0"/>
              <a:t>08/08/2022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BB10C-BE55-4C89-ADC7-1070F8C793A9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126904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63984" y="4796492"/>
            <a:ext cx="4722813" cy="11432335"/>
          </a:xfrm>
        </p:spPr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625703" y="4796492"/>
            <a:ext cx="4722813" cy="11432335"/>
          </a:xfrm>
        </p:spPr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5F8038-DA31-49FF-8515-7C916076E055}" type="datetimeFigureOut">
              <a:rPr lang="pt-BR" smtClean="0"/>
              <a:t>08/08/2022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BB10C-BE55-4C89-ADC7-1070F8C793A9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115820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5432" y="959302"/>
            <a:ext cx="9584531" cy="3482671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65433" y="4416945"/>
            <a:ext cx="4701108" cy="2164676"/>
          </a:xfrm>
        </p:spPr>
        <p:txBody>
          <a:bodyPr anchor="b"/>
          <a:lstStyle>
            <a:lvl1pPr marL="0" indent="0">
              <a:buNone/>
              <a:defRPr sz="2917" b="1"/>
            </a:lvl1pPr>
            <a:lvl2pPr marL="555635" indent="0">
              <a:buNone/>
              <a:defRPr sz="2431" b="1"/>
            </a:lvl2pPr>
            <a:lvl3pPr marL="1111270" indent="0">
              <a:buNone/>
              <a:defRPr sz="2188" b="1"/>
            </a:lvl3pPr>
            <a:lvl4pPr marL="1666905" indent="0">
              <a:buNone/>
              <a:defRPr sz="1944" b="1"/>
            </a:lvl4pPr>
            <a:lvl5pPr marL="2222541" indent="0">
              <a:buNone/>
              <a:defRPr sz="1944" b="1"/>
            </a:lvl5pPr>
            <a:lvl6pPr marL="2778176" indent="0">
              <a:buNone/>
              <a:defRPr sz="1944" b="1"/>
            </a:lvl6pPr>
            <a:lvl7pPr marL="3333811" indent="0">
              <a:buNone/>
              <a:defRPr sz="1944" b="1"/>
            </a:lvl7pPr>
            <a:lvl8pPr marL="3889446" indent="0">
              <a:buNone/>
              <a:defRPr sz="1944" b="1"/>
            </a:lvl8pPr>
            <a:lvl9pPr marL="4445081" indent="0">
              <a:buNone/>
              <a:defRPr sz="1944" b="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65433" y="6581620"/>
            <a:ext cx="4701108" cy="9680573"/>
          </a:xfrm>
        </p:spPr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625704" y="4416945"/>
            <a:ext cx="4724260" cy="2164676"/>
          </a:xfrm>
        </p:spPr>
        <p:txBody>
          <a:bodyPr anchor="b"/>
          <a:lstStyle>
            <a:lvl1pPr marL="0" indent="0">
              <a:buNone/>
              <a:defRPr sz="2917" b="1"/>
            </a:lvl1pPr>
            <a:lvl2pPr marL="555635" indent="0">
              <a:buNone/>
              <a:defRPr sz="2431" b="1"/>
            </a:lvl2pPr>
            <a:lvl3pPr marL="1111270" indent="0">
              <a:buNone/>
              <a:defRPr sz="2188" b="1"/>
            </a:lvl3pPr>
            <a:lvl4pPr marL="1666905" indent="0">
              <a:buNone/>
              <a:defRPr sz="1944" b="1"/>
            </a:lvl4pPr>
            <a:lvl5pPr marL="2222541" indent="0">
              <a:buNone/>
              <a:defRPr sz="1944" b="1"/>
            </a:lvl5pPr>
            <a:lvl6pPr marL="2778176" indent="0">
              <a:buNone/>
              <a:defRPr sz="1944" b="1"/>
            </a:lvl6pPr>
            <a:lvl7pPr marL="3333811" indent="0">
              <a:buNone/>
              <a:defRPr sz="1944" b="1"/>
            </a:lvl7pPr>
            <a:lvl8pPr marL="3889446" indent="0">
              <a:buNone/>
              <a:defRPr sz="1944" b="1"/>
            </a:lvl8pPr>
            <a:lvl9pPr marL="4445081" indent="0">
              <a:buNone/>
              <a:defRPr sz="1944" b="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625704" y="6581620"/>
            <a:ext cx="4724260" cy="9680573"/>
          </a:xfrm>
        </p:spPr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5F8038-DA31-49FF-8515-7C916076E055}" type="datetimeFigureOut">
              <a:rPr lang="pt-BR" smtClean="0"/>
              <a:t>08/08/2022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BB10C-BE55-4C89-ADC7-1070F8C793A9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879512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5F8038-DA31-49FF-8515-7C916076E055}" type="datetimeFigureOut">
              <a:rPr lang="pt-BR" smtClean="0"/>
              <a:t>08/08/2022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BB10C-BE55-4C89-ADC7-1070F8C793A9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777456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5F8038-DA31-49FF-8515-7C916076E055}" type="datetimeFigureOut">
              <a:rPr lang="pt-BR" smtClean="0"/>
              <a:t>08/08/2022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BB10C-BE55-4C89-ADC7-1070F8C793A9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712052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5432" y="1201208"/>
            <a:ext cx="3584070" cy="4204229"/>
          </a:xfrm>
        </p:spPr>
        <p:txBody>
          <a:bodyPr anchor="b"/>
          <a:lstStyle>
            <a:lvl1pPr>
              <a:defRPr sz="3889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24260" y="2594280"/>
            <a:ext cx="5625703" cy="12804547"/>
          </a:xfrm>
        </p:spPr>
        <p:txBody>
          <a:bodyPr/>
          <a:lstStyle>
            <a:lvl1pPr>
              <a:defRPr sz="3889"/>
            </a:lvl1pPr>
            <a:lvl2pPr>
              <a:defRPr sz="3403"/>
            </a:lvl2pPr>
            <a:lvl3pPr>
              <a:defRPr sz="2917"/>
            </a:lvl3pPr>
            <a:lvl4pPr>
              <a:defRPr sz="2431"/>
            </a:lvl4pPr>
            <a:lvl5pPr>
              <a:defRPr sz="2431"/>
            </a:lvl5pPr>
            <a:lvl6pPr>
              <a:defRPr sz="2431"/>
            </a:lvl6pPr>
            <a:lvl7pPr>
              <a:defRPr sz="2431"/>
            </a:lvl7pPr>
            <a:lvl8pPr>
              <a:defRPr sz="2431"/>
            </a:lvl8pPr>
            <a:lvl9pPr>
              <a:defRPr sz="2431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65432" y="5405437"/>
            <a:ext cx="3584070" cy="10014242"/>
          </a:xfrm>
        </p:spPr>
        <p:txBody>
          <a:bodyPr/>
          <a:lstStyle>
            <a:lvl1pPr marL="0" indent="0">
              <a:buNone/>
              <a:defRPr sz="1944"/>
            </a:lvl1pPr>
            <a:lvl2pPr marL="555635" indent="0">
              <a:buNone/>
              <a:defRPr sz="1701"/>
            </a:lvl2pPr>
            <a:lvl3pPr marL="1111270" indent="0">
              <a:buNone/>
              <a:defRPr sz="1458"/>
            </a:lvl3pPr>
            <a:lvl4pPr marL="1666905" indent="0">
              <a:buNone/>
              <a:defRPr sz="1215"/>
            </a:lvl4pPr>
            <a:lvl5pPr marL="2222541" indent="0">
              <a:buNone/>
              <a:defRPr sz="1215"/>
            </a:lvl5pPr>
            <a:lvl6pPr marL="2778176" indent="0">
              <a:buNone/>
              <a:defRPr sz="1215"/>
            </a:lvl6pPr>
            <a:lvl7pPr marL="3333811" indent="0">
              <a:buNone/>
              <a:defRPr sz="1215"/>
            </a:lvl7pPr>
            <a:lvl8pPr marL="3889446" indent="0">
              <a:buNone/>
              <a:defRPr sz="1215"/>
            </a:lvl8pPr>
            <a:lvl9pPr marL="4445081" indent="0">
              <a:buNone/>
              <a:defRPr sz="1215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5F8038-DA31-49FF-8515-7C916076E055}" type="datetimeFigureOut">
              <a:rPr lang="pt-BR" smtClean="0"/>
              <a:t>08/08/2022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BB10C-BE55-4C89-ADC7-1070F8C793A9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945214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5432" y="1201208"/>
            <a:ext cx="3584070" cy="4204229"/>
          </a:xfrm>
        </p:spPr>
        <p:txBody>
          <a:bodyPr anchor="b"/>
          <a:lstStyle>
            <a:lvl1pPr>
              <a:defRPr sz="3889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724260" y="2594280"/>
            <a:ext cx="5625703" cy="12804547"/>
          </a:xfrm>
        </p:spPr>
        <p:txBody>
          <a:bodyPr anchor="t"/>
          <a:lstStyle>
            <a:lvl1pPr marL="0" indent="0">
              <a:buNone/>
              <a:defRPr sz="3889"/>
            </a:lvl1pPr>
            <a:lvl2pPr marL="555635" indent="0">
              <a:buNone/>
              <a:defRPr sz="3403"/>
            </a:lvl2pPr>
            <a:lvl3pPr marL="1111270" indent="0">
              <a:buNone/>
              <a:defRPr sz="2917"/>
            </a:lvl3pPr>
            <a:lvl4pPr marL="1666905" indent="0">
              <a:buNone/>
              <a:defRPr sz="2431"/>
            </a:lvl4pPr>
            <a:lvl5pPr marL="2222541" indent="0">
              <a:buNone/>
              <a:defRPr sz="2431"/>
            </a:lvl5pPr>
            <a:lvl6pPr marL="2778176" indent="0">
              <a:buNone/>
              <a:defRPr sz="2431"/>
            </a:lvl6pPr>
            <a:lvl7pPr marL="3333811" indent="0">
              <a:buNone/>
              <a:defRPr sz="2431"/>
            </a:lvl7pPr>
            <a:lvl8pPr marL="3889446" indent="0">
              <a:buNone/>
              <a:defRPr sz="2431"/>
            </a:lvl8pPr>
            <a:lvl9pPr marL="4445081" indent="0">
              <a:buNone/>
              <a:defRPr sz="2431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65432" y="5405437"/>
            <a:ext cx="3584070" cy="10014242"/>
          </a:xfrm>
        </p:spPr>
        <p:txBody>
          <a:bodyPr/>
          <a:lstStyle>
            <a:lvl1pPr marL="0" indent="0">
              <a:buNone/>
              <a:defRPr sz="1944"/>
            </a:lvl1pPr>
            <a:lvl2pPr marL="555635" indent="0">
              <a:buNone/>
              <a:defRPr sz="1701"/>
            </a:lvl2pPr>
            <a:lvl3pPr marL="1111270" indent="0">
              <a:buNone/>
              <a:defRPr sz="1458"/>
            </a:lvl3pPr>
            <a:lvl4pPr marL="1666905" indent="0">
              <a:buNone/>
              <a:defRPr sz="1215"/>
            </a:lvl4pPr>
            <a:lvl5pPr marL="2222541" indent="0">
              <a:buNone/>
              <a:defRPr sz="1215"/>
            </a:lvl5pPr>
            <a:lvl6pPr marL="2778176" indent="0">
              <a:buNone/>
              <a:defRPr sz="1215"/>
            </a:lvl6pPr>
            <a:lvl7pPr marL="3333811" indent="0">
              <a:buNone/>
              <a:defRPr sz="1215"/>
            </a:lvl7pPr>
            <a:lvl8pPr marL="3889446" indent="0">
              <a:buNone/>
              <a:defRPr sz="1215"/>
            </a:lvl8pPr>
            <a:lvl9pPr marL="4445081" indent="0">
              <a:buNone/>
              <a:defRPr sz="1215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5F8038-DA31-49FF-8515-7C916076E055}" type="datetimeFigureOut">
              <a:rPr lang="pt-BR" smtClean="0"/>
              <a:t>08/08/2022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BB10C-BE55-4C89-ADC7-1070F8C793A9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0630050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63985" y="959302"/>
            <a:ext cx="9584531" cy="348267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63985" y="4796492"/>
            <a:ext cx="9584531" cy="1143233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63984" y="16700137"/>
            <a:ext cx="2500313" cy="95929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5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5F8038-DA31-49FF-8515-7C916076E055}" type="datetimeFigureOut">
              <a:rPr lang="pt-BR" smtClean="0"/>
              <a:t>08/08/2022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81016" y="16700137"/>
            <a:ext cx="3750469" cy="95929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5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848203" y="16700137"/>
            <a:ext cx="2500313" cy="95929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5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FBB10C-BE55-4C89-ADC7-1070F8C793A9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486217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111270" rtl="0" eaLnBrk="1" latinLnBrk="0" hangingPunct="1">
        <a:lnSpc>
          <a:spcPct val="90000"/>
        </a:lnSpc>
        <a:spcBef>
          <a:spcPct val="0"/>
        </a:spcBef>
        <a:buNone/>
        <a:defRPr sz="534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7818" indent="-277818" algn="l" defTabSz="1111270" rtl="0" eaLnBrk="1" latinLnBrk="0" hangingPunct="1">
        <a:lnSpc>
          <a:spcPct val="90000"/>
        </a:lnSpc>
        <a:spcBef>
          <a:spcPts val="1215"/>
        </a:spcBef>
        <a:buFont typeface="Arial" panose="020B0604020202020204" pitchFamily="34" charset="0"/>
        <a:buChar char="•"/>
        <a:defRPr sz="3403" kern="1200">
          <a:solidFill>
            <a:schemeClr val="tx1"/>
          </a:solidFill>
          <a:latin typeface="+mn-lt"/>
          <a:ea typeface="+mn-ea"/>
          <a:cs typeface="+mn-cs"/>
        </a:defRPr>
      </a:lvl1pPr>
      <a:lvl2pPr marL="833453" indent="-277818" algn="l" defTabSz="1111270" rtl="0" eaLnBrk="1" latinLnBrk="0" hangingPunct="1">
        <a:lnSpc>
          <a:spcPct val="90000"/>
        </a:lnSpc>
        <a:spcBef>
          <a:spcPts val="608"/>
        </a:spcBef>
        <a:buFont typeface="Arial" panose="020B0604020202020204" pitchFamily="34" charset="0"/>
        <a:buChar char="•"/>
        <a:defRPr sz="2917" kern="1200">
          <a:solidFill>
            <a:schemeClr val="tx1"/>
          </a:solidFill>
          <a:latin typeface="+mn-lt"/>
          <a:ea typeface="+mn-ea"/>
          <a:cs typeface="+mn-cs"/>
        </a:defRPr>
      </a:lvl2pPr>
      <a:lvl3pPr marL="1389088" indent="-277818" algn="l" defTabSz="1111270" rtl="0" eaLnBrk="1" latinLnBrk="0" hangingPunct="1">
        <a:lnSpc>
          <a:spcPct val="90000"/>
        </a:lnSpc>
        <a:spcBef>
          <a:spcPts val="608"/>
        </a:spcBef>
        <a:buFont typeface="Arial" panose="020B0604020202020204" pitchFamily="34" charset="0"/>
        <a:buChar char="•"/>
        <a:defRPr sz="2431" kern="1200">
          <a:solidFill>
            <a:schemeClr val="tx1"/>
          </a:solidFill>
          <a:latin typeface="+mn-lt"/>
          <a:ea typeface="+mn-ea"/>
          <a:cs typeface="+mn-cs"/>
        </a:defRPr>
      </a:lvl3pPr>
      <a:lvl4pPr marL="1944723" indent="-277818" algn="l" defTabSz="1111270" rtl="0" eaLnBrk="1" latinLnBrk="0" hangingPunct="1">
        <a:lnSpc>
          <a:spcPct val="90000"/>
        </a:lnSpc>
        <a:spcBef>
          <a:spcPts val="608"/>
        </a:spcBef>
        <a:buFont typeface="Arial" panose="020B0604020202020204" pitchFamily="34" charset="0"/>
        <a:buChar char="•"/>
        <a:defRPr sz="2188" kern="1200">
          <a:solidFill>
            <a:schemeClr val="tx1"/>
          </a:solidFill>
          <a:latin typeface="+mn-lt"/>
          <a:ea typeface="+mn-ea"/>
          <a:cs typeface="+mn-cs"/>
        </a:defRPr>
      </a:lvl4pPr>
      <a:lvl5pPr marL="2500358" indent="-277818" algn="l" defTabSz="1111270" rtl="0" eaLnBrk="1" latinLnBrk="0" hangingPunct="1">
        <a:lnSpc>
          <a:spcPct val="90000"/>
        </a:lnSpc>
        <a:spcBef>
          <a:spcPts val="608"/>
        </a:spcBef>
        <a:buFont typeface="Arial" panose="020B0604020202020204" pitchFamily="34" charset="0"/>
        <a:buChar char="•"/>
        <a:defRPr sz="2188" kern="1200">
          <a:solidFill>
            <a:schemeClr val="tx1"/>
          </a:solidFill>
          <a:latin typeface="+mn-lt"/>
          <a:ea typeface="+mn-ea"/>
          <a:cs typeface="+mn-cs"/>
        </a:defRPr>
      </a:lvl5pPr>
      <a:lvl6pPr marL="3055993" indent="-277818" algn="l" defTabSz="1111270" rtl="0" eaLnBrk="1" latinLnBrk="0" hangingPunct="1">
        <a:lnSpc>
          <a:spcPct val="90000"/>
        </a:lnSpc>
        <a:spcBef>
          <a:spcPts val="608"/>
        </a:spcBef>
        <a:buFont typeface="Arial" panose="020B0604020202020204" pitchFamily="34" charset="0"/>
        <a:buChar char="•"/>
        <a:defRPr sz="2188" kern="1200">
          <a:solidFill>
            <a:schemeClr val="tx1"/>
          </a:solidFill>
          <a:latin typeface="+mn-lt"/>
          <a:ea typeface="+mn-ea"/>
          <a:cs typeface="+mn-cs"/>
        </a:defRPr>
      </a:lvl6pPr>
      <a:lvl7pPr marL="3611629" indent="-277818" algn="l" defTabSz="1111270" rtl="0" eaLnBrk="1" latinLnBrk="0" hangingPunct="1">
        <a:lnSpc>
          <a:spcPct val="90000"/>
        </a:lnSpc>
        <a:spcBef>
          <a:spcPts val="608"/>
        </a:spcBef>
        <a:buFont typeface="Arial" panose="020B0604020202020204" pitchFamily="34" charset="0"/>
        <a:buChar char="•"/>
        <a:defRPr sz="2188" kern="1200">
          <a:solidFill>
            <a:schemeClr val="tx1"/>
          </a:solidFill>
          <a:latin typeface="+mn-lt"/>
          <a:ea typeface="+mn-ea"/>
          <a:cs typeface="+mn-cs"/>
        </a:defRPr>
      </a:lvl7pPr>
      <a:lvl8pPr marL="4167264" indent="-277818" algn="l" defTabSz="1111270" rtl="0" eaLnBrk="1" latinLnBrk="0" hangingPunct="1">
        <a:lnSpc>
          <a:spcPct val="90000"/>
        </a:lnSpc>
        <a:spcBef>
          <a:spcPts val="608"/>
        </a:spcBef>
        <a:buFont typeface="Arial" panose="020B0604020202020204" pitchFamily="34" charset="0"/>
        <a:buChar char="•"/>
        <a:defRPr sz="2188" kern="1200">
          <a:solidFill>
            <a:schemeClr val="tx1"/>
          </a:solidFill>
          <a:latin typeface="+mn-lt"/>
          <a:ea typeface="+mn-ea"/>
          <a:cs typeface="+mn-cs"/>
        </a:defRPr>
      </a:lvl8pPr>
      <a:lvl9pPr marL="4722899" indent="-277818" algn="l" defTabSz="1111270" rtl="0" eaLnBrk="1" latinLnBrk="0" hangingPunct="1">
        <a:lnSpc>
          <a:spcPct val="90000"/>
        </a:lnSpc>
        <a:spcBef>
          <a:spcPts val="608"/>
        </a:spcBef>
        <a:buFont typeface="Arial" panose="020B0604020202020204" pitchFamily="34" charset="0"/>
        <a:buChar char="•"/>
        <a:defRPr sz="21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11270" rtl="0" eaLnBrk="1" latinLnBrk="0" hangingPunct="1">
        <a:defRPr sz="2188" kern="1200">
          <a:solidFill>
            <a:schemeClr val="tx1"/>
          </a:solidFill>
          <a:latin typeface="+mn-lt"/>
          <a:ea typeface="+mn-ea"/>
          <a:cs typeface="+mn-cs"/>
        </a:defRPr>
      </a:lvl1pPr>
      <a:lvl2pPr marL="555635" algn="l" defTabSz="1111270" rtl="0" eaLnBrk="1" latinLnBrk="0" hangingPunct="1">
        <a:defRPr sz="2188" kern="1200">
          <a:solidFill>
            <a:schemeClr val="tx1"/>
          </a:solidFill>
          <a:latin typeface="+mn-lt"/>
          <a:ea typeface="+mn-ea"/>
          <a:cs typeface="+mn-cs"/>
        </a:defRPr>
      </a:lvl2pPr>
      <a:lvl3pPr marL="1111270" algn="l" defTabSz="1111270" rtl="0" eaLnBrk="1" latinLnBrk="0" hangingPunct="1">
        <a:defRPr sz="2188" kern="1200">
          <a:solidFill>
            <a:schemeClr val="tx1"/>
          </a:solidFill>
          <a:latin typeface="+mn-lt"/>
          <a:ea typeface="+mn-ea"/>
          <a:cs typeface="+mn-cs"/>
        </a:defRPr>
      </a:lvl3pPr>
      <a:lvl4pPr marL="1666905" algn="l" defTabSz="1111270" rtl="0" eaLnBrk="1" latinLnBrk="0" hangingPunct="1">
        <a:defRPr sz="2188" kern="1200">
          <a:solidFill>
            <a:schemeClr val="tx1"/>
          </a:solidFill>
          <a:latin typeface="+mn-lt"/>
          <a:ea typeface="+mn-ea"/>
          <a:cs typeface="+mn-cs"/>
        </a:defRPr>
      </a:lvl4pPr>
      <a:lvl5pPr marL="2222541" algn="l" defTabSz="1111270" rtl="0" eaLnBrk="1" latinLnBrk="0" hangingPunct="1">
        <a:defRPr sz="2188" kern="1200">
          <a:solidFill>
            <a:schemeClr val="tx1"/>
          </a:solidFill>
          <a:latin typeface="+mn-lt"/>
          <a:ea typeface="+mn-ea"/>
          <a:cs typeface="+mn-cs"/>
        </a:defRPr>
      </a:lvl5pPr>
      <a:lvl6pPr marL="2778176" algn="l" defTabSz="1111270" rtl="0" eaLnBrk="1" latinLnBrk="0" hangingPunct="1">
        <a:defRPr sz="2188" kern="1200">
          <a:solidFill>
            <a:schemeClr val="tx1"/>
          </a:solidFill>
          <a:latin typeface="+mn-lt"/>
          <a:ea typeface="+mn-ea"/>
          <a:cs typeface="+mn-cs"/>
        </a:defRPr>
      </a:lvl6pPr>
      <a:lvl7pPr marL="3333811" algn="l" defTabSz="1111270" rtl="0" eaLnBrk="1" latinLnBrk="0" hangingPunct="1">
        <a:defRPr sz="2188" kern="1200">
          <a:solidFill>
            <a:schemeClr val="tx1"/>
          </a:solidFill>
          <a:latin typeface="+mn-lt"/>
          <a:ea typeface="+mn-ea"/>
          <a:cs typeface="+mn-cs"/>
        </a:defRPr>
      </a:lvl7pPr>
      <a:lvl8pPr marL="3889446" algn="l" defTabSz="1111270" rtl="0" eaLnBrk="1" latinLnBrk="0" hangingPunct="1">
        <a:defRPr sz="2188" kern="1200">
          <a:solidFill>
            <a:schemeClr val="tx1"/>
          </a:solidFill>
          <a:latin typeface="+mn-lt"/>
          <a:ea typeface="+mn-ea"/>
          <a:cs typeface="+mn-cs"/>
        </a:defRPr>
      </a:lvl8pPr>
      <a:lvl9pPr marL="4445081" algn="l" defTabSz="1111270" rtl="0" eaLnBrk="1" latinLnBrk="0" hangingPunct="1">
        <a:defRPr sz="21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Agrupar 30">
            <a:extLst>
              <a:ext uri="{FF2B5EF4-FFF2-40B4-BE49-F238E27FC236}">
                <a16:creationId xmlns:a16="http://schemas.microsoft.com/office/drawing/2014/main" id="{4B7B80C4-D17D-41F4-9D0B-18EFE86D390C}"/>
              </a:ext>
            </a:extLst>
          </p:cNvPr>
          <p:cNvGrpSpPr/>
          <p:nvPr/>
        </p:nvGrpSpPr>
        <p:grpSpPr>
          <a:xfrm>
            <a:off x="1875867" y="2137922"/>
            <a:ext cx="7113040" cy="10289802"/>
            <a:chOff x="1630397" y="1999380"/>
            <a:chExt cx="7113040" cy="10289802"/>
          </a:xfrm>
        </p:grpSpPr>
        <p:pic>
          <p:nvPicPr>
            <p:cNvPr id="25" name="Imagem 24">
              <a:extLst>
                <a:ext uri="{FF2B5EF4-FFF2-40B4-BE49-F238E27FC236}">
                  <a16:creationId xmlns:a16="http://schemas.microsoft.com/office/drawing/2014/main" id="{BDD766D3-6A21-489F-8150-8F5AACF4EA2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38167" y="9610264"/>
              <a:ext cx="7105270" cy="2678918"/>
            </a:xfrm>
            <a:prstGeom prst="rect">
              <a:avLst/>
            </a:prstGeom>
          </p:spPr>
        </p:pic>
        <p:grpSp>
          <p:nvGrpSpPr>
            <p:cNvPr id="8" name="Agrupar 7">
              <a:extLst>
                <a:ext uri="{FF2B5EF4-FFF2-40B4-BE49-F238E27FC236}">
                  <a16:creationId xmlns:a16="http://schemas.microsoft.com/office/drawing/2014/main" id="{FCADFC38-1A02-4361-B65D-872005203B75}"/>
                </a:ext>
              </a:extLst>
            </p:cNvPr>
            <p:cNvGrpSpPr/>
            <p:nvPr/>
          </p:nvGrpSpPr>
          <p:grpSpPr>
            <a:xfrm>
              <a:off x="1630397" y="1999380"/>
              <a:ext cx="7084591" cy="9335662"/>
              <a:chOff x="1326110" y="2572365"/>
              <a:chExt cx="8426442" cy="11192494"/>
            </a:xfrm>
          </p:grpSpPr>
          <p:grpSp>
            <p:nvGrpSpPr>
              <p:cNvPr id="5" name="Agrupar 4">
                <a:extLst>
                  <a:ext uri="{FF2B5EF4-FFF2-40B4-BE49-F238E27FC236}">
                    <a16:creationId xmlns:a16="http://schemas.microsoft.com/office/drawing/2014/main" id="{26C4EE2C-45A3-4F65-89CB-93CD2612A0EB}"/>
                  </a:ext>
                </a:extLst>
              </p:cNvPr>
              <p:cNvGrpSpPr/>
              <p:nvPr/>
            </p:nvGrpSpPr>
            <p:grpSpPr>
              <a:xfrm>
                <a:off x="1326110" y="2572365"/>
                <a:ext cx="8426442" cy="10760431"/>
                <a:chOff x="1326110" y="2572365"/>
                <a:chExt cx="8426442" cy="10760431"/>
              </a:xfrm>
            </p:grpSpPr>
            <p:grpSp>
              <p:nvGrpSpPr>
                <p:cNvPr id="15" name="Agrupar 14">
                  <a:extLst>
                    <a:ext uri="{FF2B5EF4-FFF2-40B4-BE49-F238E27FC236}">
                      <a16:creationId xmlns:a16="http://schemas.microsoft.com/office/drawing/2014/main" id="{95D717F8-34B1-4040-A7EC-0CBFECA360CB}"/>
                    </a:ext>
                  </a:extLst>
                </p:cNvPr>
                <p:cNvGrpSpPr/>
                <p:nvPr/>
              </p:nvGrpSpPr>
              <p:grpSpPr>
                <a:xfrm>
                  <a:off x="1326110" y="2572365"/>
                  <a:ext cx="8426442" cy="9138651"/>
                  <a:chOff x="1939826" y="1795685"/>
                  <a:chExt cx="6483697" cy="7773459"/>
                </a:xfrm>
              </p:grpSpPr>
              <p:pic>
                <p:nvPicPr>
                  <p:cNvPr id="6" name="Imagem 5">
                    <a:extLst>
                      <a:ext uri="{FF2B5EF4-FFF2-40B4-BE49-F238E27FC236}">
                        <a16:creationId xmlns:a16="http://schemas.microsoft.com/office/drawing/2014/main" id="{C1266D45-4F59-41F2-A889-C7C281086C9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/>
                  <a:stretch>
                    <a:fillRect/>
                  </a:stretch>
                </p:blipFill>
                <p:spPr>
                  <a:xfrm>
                    <a:off x="1939828" y="1795685"/>
                    <a:ext cx="6399072" cy="2525778"/>
                  </a:xfrm>
                  <a:prstGeom prst="rect">
                    <a:avLst/>
                  </a:prstGeom>
                </p:spPr>
              </p:pic>
              <p:pic>
                <p:nvPicPr>
                  <p:cNvPr id="10" name="Imagem 9">
                    <a:extLst>
                      <a:ext uri="{FF2B5EF4-FFF2-40B4-BE49-F238E27FC236}">
                        <a16:creationId xmlns:a16="http://schemas.microsoft.com/office/drawing/2014/main" id="{7B179D6A-5FF8-4279-8E27-79F87D28A4E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5"/>
                  <a:stretch>
                    <a:fillRect/>
                  </a:stretch>
                </p:blipFill>
                <p:spPr>
                  <a:xfrm>
                    <a:off x="1939826" y="4408587"/>
                    <a:ext cx="6483697" cy="2525777"/>
                  </a:xfrm>
                  <a:prstGeom prst="rect">
                    <a:avLst/>
                  </a:prstGeom>
                </p:spPr>
              </p:pic>
              <p:pic>
                <p:nvPicPr>
                  <p:cNvPr id="12" name="Imagem 11">
                    <a:extLst>
                      <a:ext uri="{FF2B5EF4-FFF2-40B4-BE49-F238E27FC236}">
                        <a16:creationId xmlns:a16="http://schemas.microsoft.com/office/drawing/2014/main" id="{348E0964-54F7-430C-8B74-A4EDB31B530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6"/>
                  <a:stretch>
                    <a:fillRect/>
                  </a:stretch>
                </p:blipFill>
                <p:spPr>
                  <a:xfrm>
                    <a:off x="1939827" y="7086304"/>
                    <a:ext cx="6399073" cy="2482840"/>
                  </a:xfrm>
                  <a:prstGeom prst="rect">
                    <a:avLst/>
                  </a:prstGeom>
                </p:spPr>
              </p:pic>
            </p:grpSp>
            <p:cxnSp>
              <p:nvCxnSpPr>
                <p:cNvPr id="4" name="Conector reto 3">
                  <a:extLst>
                    <a:ext uri="{FF2B5EF4-FFF2-40B4-BE49-F238E27FC236}">
                      <a16:creationId xmlns:a16="http://schemas.microsoft.com/office/drawing/2014/main" id="{87F24DCA-E4BF-426D-8E28-2B8CE62FDEAA}"/>
                    </a:ext>
                  </a:extLst>
                </p:cNvPr>
                <p:cNvCxnSpPr/>
                <p:nvPr/>
              </p:nvCxnSpPr>
              <p:spPr>
                <a:xfrm>
                  <a:off x="6063342" y="4089703"/>
                  <a:ext cx="3564000" cy="0"/>
                </a:xfrm>
                <a:prstGeom prst="line">
                  <a:avLst/>
                </a:prstGeom>
                <a:ln w="19050">
                  <a:solidFill>
                    <a:srgbClr val="FF0000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" name="Conector reto 10">
                  <a:extLst>
                    <a:ext uri="{FF2B5EF4-FFF2-40B4-BE49-F238E27FC236}">
                      <a16:creationId xmlns:a16="http://schemas.microsoft.com/office/drawing/2014/main" id="{0B15DE78-C5C9-47A4-8B1B-91AFB58DB1FA}"/>
                    </a:ext>
                  </a:extLst>
                </p:cNvPr>
                <p:cNvCxnSpPr/>
                <p:nvPr/>
              </p:nvCxnSpPr>
              <p:spPr>
                <a:xfrm>
                  <a:off x="6089458" y="7194147"/>
                  <a:ext cx="3564000" cy="0"/>
                </a:xfrm>
                <a:prstGeom prst="line">
                  <a:avLst/>
                </a:prstGeom>
                <a:ln w="19050">
                  <a:solidFill>
                    <a:srgbClr val="FF0000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Conector reto 12">
                  <a:extLst>
                    <a:ext uri="{FF2B5EF4-FFF2-40B4-BE49-F238E27FC236}">
                      <a16:creationId xmlns:a16="http://schemas.microsoft.com/office/drawing/2014/main" id="{AA50B968-B87B-4B52-8215-6DA415EE8BF6}"/>
                    </a:ext>
                  </a:extLst>
                </p:cNvPr>
                <p:cNvCxnSpPr/>
                <p:nvPr/>
              </p:nvCxnSpPr>
              <p:spPr>
                <a:xfrm>
                  <a:off x="6089458" y="10251575"/>
                  <a:ext cx="3564000" cy="0"/>
                </a:xfrm>
                <a:prstGeom prst="line">
                  <a:avLst/>
                </a:prstGeom>
                <a:ln w="19050">
                  <a:solidFill>
                    <a:srgbClr val="FF0000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Conector reto 15">
                  <a:extLst>
                    <a:ext uri="{FF2B5EF4-FFF2-40B4-BE49-F238E27FC236}">
                      <a16:creationId xmlns:a16="http://schemas.microsoft.com/office/drawing/2014/main" id="{47B6CE7E-0823-4505-BEED-6BAA398DCBD8}"/>
                    </a:ext>
                  </a:extLst>
                </p:cNvPr>
                <p:cNvCxnSpPr/>
                <p:nvPr/>
              </p:nvCxnSpPr>
              <p:spPr>
                <a:xfrm>
                  <a:off x="6131761" y="13332796"/>
                  <a:ext cx="3563998" cy="0"/>
                </a:xfrm>
                <a:prstGeom prst="line">
                  <a:avLst/>
                </a:prstGeom>
                <a:ln w="19050">
                  <a:solidFill>
                    <a:srgbClr val="FF0000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" name="CaixaDeTexto 6">
                <a:extLst>
                  <a:ext uri="{FF2B5EF4-FFF2-40B4-BE49-F238E27FC236}">
                    <a16:creationId xmlns:a16="http://schemas.microsoft.com/office/drawing/2014/main" id="{964BC72F-31BB-4ED2-A6D2-0262BB13D605}"/>
                  </a:ext>
                </a:extLst>
              </p:cNvPr>
              <p:cNvSpPr txBox="1"/>
              <p:nvPr/>
            </p:nvSpPr>
            <p:spPr>
              <a:xfrm>
                <a:off x="6370320" y="7468000"/>
                <a:ext cx="39624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BR" sz="1400" b="1" dirty="0">
                    <a:solidFill>
                      <a:srgbClr val="FF0000"/>
                    </a:solidFill>
                  </a:rPr>
                  <a:t>*</a:t>
                </a:r>
              </a:p>
            </p:txBody>
          </p:sp>
          <p:sp>
            <p:nvSpPr>
              <p:cNvPr id="17" name="CaixaDeTexto 16">
                <a:extLst>
                  <a:ext uri="{FF2B5EF4-FFF2-40B4-BE49-F238E27FC236}">
                    <a16:creationId xmlns:a16="http://schemas.microsoft.com/office/drawing/2014/main" id="{819B1F11-A1C6-42D4-AE06-C019A166884A}"/>
                  </a:ext>
                </a:extLst>
              </p:cNvPr>
              <p:cNvSpPr txBox="1"/>
              <p:nvPr/>
            </p:nvSpPr>
            <p:spPr>
              <a:xfrm>
                <a:off x="7117899" y="7197044"/>
                <a:ext cx="396240" cy="3320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BR" sz="1200" b="1" dirty="0">
                    <a:solidFill>
                      <a:srgbClr val="FF0000"/>
                    </a:solidFill>
                  </a:rPr>
                  <a:t>*</a:t>
                </a:r>
              </a:p>
            </p:txBody>
          </p:sp>
          <p:sp>
            <p:nvSpPr>
              <p:cNvPr id="18" name="CaixaDeTexto 17">
                <a:extLst>
                  <a:ext uri="{FF2B5EF4-FFF2-40B4-BE49-F238E27FC236}">
                    <a16:creationId xmlns:a16="http://schemas.microsoft.com/office/drawing/2014/main" id="{A414B248-A295-4B67-8475-4330E8E25C31}"/>
                  </a:ext>
                </a:extLst>
              </p:cNvPr>
              <p:cNvSpPr txBox="1"/>
              <p:nvPr/>
            </p:nvSpPr>
            <p:spPr>
              <a:xfrm>
                <a:off x="7310866" y="7210805"/>
                <a:ext cx="396240" cy="3320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BR" sz="1200" b="1" dirty="0">
                    <a:solidFill>
                      <a:srgbClr val="FF0000"/>
                    </a:solidFill>
                  </a:rPr>
                  <a:t>*</a:t>
                </a:r>
              </a:p>
            </p:txBody>
          </p:sp>
          <p:sp>
            <p:nvSpPr>
              <p:cNvPr id="19" name="CaixaDeTexto 18">
                <a:extLst>
                  <a:ext uri="{FF2B5EF4-FFF2-40B4-BE49-F238E27FC236}">
                    <a16:creationId xmlns:a16="http://schemas.microsoft.com/office/drawing/2014/main" id="{D6148956-1ECC-4CB9-8B78-B177F8CA3684}"/>
                  </a:ext>
                </a:extLst>
              </p:cNvPr>
              <p:cNvSpPr txBox="1"/>
              <p:nvPr/>
            </p:nvSpPr>
            <p:spPr>
              <a:xfrm>
                <a:off x="6461759" y="10376108"/>
                <a:ext cx="396240" cy="3320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BR" sz="1200" b="1" dirty="0">
                    <a:solidFill>
                      <a:srgbClr val="FF0000"/>
                    </a:solidFill>
                  </a:rPr>
                  <a:t>*</a:t>
                </a:r>
              </a:p>
            </p:txBody>
          </p:sp>
          <p:sp>
            <p:nvSpPr>
              <p:cNvPr id="20" name="CaixaDeTexto 19">
                <a:extLst>
                  <a:ext uri="{FF2B5EF4-FFF2-40B4-BE49-F238E27FC236}">
                    <a16:creationId xmlns:a16="http://schemas.microsoft.com/office/drawing/2014/main" id="{221CD8EE-1557-4F1B-A766-755B8C0A72B9}"/>
                  </a:ext>
                </a:extLst>
              </p:cNvPr>
              <p:cNvSpPr txBox="1"/>
              <p:nvPr/>
            </p:nvSpPr>
            <p:spPr>
              <a:xfrm>
                <a:off x="7255010" y="10261836"/>
                <a:ext cx="396240" cy="3320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BR" sz="1200" b="1" dirty="0">
                    <a:solidFill>
                      <a:srgbClr val="FF0000"/>
                    </a:solidFill>
                  </a:rPr>
                  <a:t>*</a:t>
                </a:r>
              </a:p>
            </p:txBody>
          </p:sp>
          <p:sp>
            <p:nvSpPr>
              <p:cNvPr id="21" name="CaixaDeTexto 20">
                <a:extLst>
                  <a:ext uri="{FF2B5EF4-FFF2-40B4-BE49-F238E27FC236}">
                    <a16:creationId xmlns:a16="http://schemas.microsoft.com/office/drawing/2014/main" id="{B27E727B-736B-44F3-9D60-5164C72F931A}"/>
                  </a:ext>
                </a:extLst>
              </p:cNvPr>
              <p:cNvSpPr txBox="1"/>
              <p:nvPr/>
            </p:nvSpPr>
            <p:spPr>
              <a:xfrm>
                <a:off x="7089886" y="10170172"/>
                <a:ext cx="396240" cy="3320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BR" sz="1200" b="1" dirty="0">
                    <a:solidFill>
                      <a:srgbClr val="FF0000"/>
                    </a:solidFill>
                  </a:rPr>
                  <a:t>*</a:t>
                </a:r>
              </a:p>
            </p:txBody>
          </p:sp>
          <p:sp>
            <p:nvSpPr>
              <p:cNvPr id="22" name="CaixaDeTexto 21">
                <a:extLst>
                  <a:ext uri="{FF2B5EF4-FFF2-40B4-BE49-F238E27FC236}">
                    <a16:creationId xmlns:a16="http://schemas.microsoft.com/office/drawing/2014/main" id="{9E7C2AF3-2656-4BB1-8612-FD2E61BDC5E0}"/>
                  </a:ext>
                </a:extLst>
              </p:cNvPr>
              <p:cNvSpPr txBox="1"/>
              <p:nvPr/>
            </p:nvSpPr>
            <p:spPr>
              <a:xfrm>
                <a:off x="6348318" y="13376452"/>
                <a:ext cx="396240" cy="3320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BR" sz="1200" b="1" dirty="0">
                    <a:solidFill>
                      <a:srgbClr val="FF0000"/>
                    </a:solidFill>
                  </a:rPr>
                  <a:t>*</a:t>
                </a:r>
              </a:p>
            </p:txBody>
          </p:sp>
          <p:sp>
            <p:nvSpPr>
              <p:cNvPr id="23" name="CaixaDeTexto 22">
                <a:extLst>
                  <a:ext uri="{FF2B5EF4-FFF2-40B4-BE49-F238E27FC236}">
                    <a16:creationId xmlns:a16="http://schemas.microsoft.com/office/drawing/2014/main" id="{ED435F56-D75D-48F3-AA2C-0DFA749C1BE1}"/>
                  </a:ext>
                </a:extLst>
              </p:cNvPr>
              <p:cNvSpPr txBox="1"/>
              <p:nvPr/>
            </p:nvSpPr>
            <p:spPr>
              <a:xfrm>
                <a:off x="7263290" y="13432766"/>
                <a:ext cx="396240" cy="3320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BR" sz="1200" b="1" dirty="0">
                    <a:solidFill>
                      <a:srgbClr val="FF0000"/>
                    </a:solidFill>
                  </a:rPr>
                  <a:t>*</a:t>
                </a:r>
              </a:p>
            </p:txBody>
          </p:sp>
          <p:sp>
            <p:nvSpPr>
              <p:cNvPr id="3" name="CaixaDeTexto 23">
                <a:extLst>
                  <a:ext uri="{FF2B5EF4-FFF2-40B4-BE49-F238E27FC236}">
                    <a16:creationId xmlns:a16="http://schemas.microsoft.com/office/drawing/2014/main" id="{1FF487C4-9497-4A59-8E3B-0D8DE925E3F2}"/>
                  </a:ext>
                </a:extLst>
              </p:cNvPr>
              <p:cNvSpPr txBox="1"/>
              <p:nvPr/>
            </p:nvSpPr>
            <p:spPr>
              <a:xfrm>
                <a:off x="7401068" y="13261378"/>
                <a:ext cx="396240" cy="3320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BR" sz="1200" b="1" dirty="0">
                    <a:solidFill>
                      <a:srgbClr val="FF0000"/>
                    </a:solidFill>
                  </a:rPr>
                  <a:t>*</a:t>
                </a:r>
              </a:p>
            </p:txBody>
          </p:sp>
          <p:sp>
            <p:nvSpPr>
              <p:cNvPr id="26" name="CaixaDeTexto 25">
                <a:extLst>
                  <a:ext uri="{FF2B5EF4-FFF2-40B4-BE49-F238E27FC236}">
                    <a16:creationId xmlns:a16="http://schemas.microsoft.com/office/drawing/2014/main" id="{E1A617F6-2991-4D3A-BF0D-AF66107219B9}"/>
                  </a:ext>
                </a:extLst>
              </p:cNvPr>
              <p:cNvSpPr txBox="1"/>
              <p:nvPr/>
            </p:nvSpPr>
            <p:spPr>
              <a:xfrm>
                <a:off x="6340113" y="4263623"/>
                <a:ext cx="396240" cy="3320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BR" sz="1200" b="1" dirty="0">
                    <a:solidFill>
                      <a:srgbClr val="FF0000"/>
                    </a:solidFill>
                  </a:rPr>
                  <a:t>*</a:t>
                </a:r>
              </a:p>
            </p:txBody>
          </p:sp>
          <p:sp>
            <p:nvSpPr>
              <p:cNvPr id="27" name="CaixaDeTexto 26">
                <a:extLst>
                  <a:ext uri="{FF2B5EF4-FFF2-40B4-BE49-F238E27FC236}">
                    <a16:creationId xmlns:a16="http://schemas.microsoft.com/office/drawing/2014/main" id="{4C2E46BB-46DC-4101-9AD5-ECFC1DDF40FB}"/>
                  </a:ext>
                </a:extLst>
              </p:cNvPr>
              <p:cNvSpPr txBox="1"/>
              <p:nvPr/>
            </p:nvSpPr>
            <p:spPr>
              <a:xfrm>
                <a:off x="7019134" y="4105955"/>
                <a:ext cx="396240" cy="3320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BR" sz="1200" b="1" dirty="0">
                    <a:solidFill>
                      <a:srgbClr val="FF0000"/>
                    </a:solidFill>
                  </a:rPr>
                  <a:t>*</a:t>
                </a:r>
              </a:p>
            </p:txBody>
          </p:sp>
          <p:sp>
            <p:nvSpPr>
              <p:cNvPr id="28" name="CaixaDeTexto 27">
                <a:extLst>
                  <a:ext uri="{FF2B5EF4-FFF2-40B4-BE49-F238E27FC236}">
                    <a16:creationId xmlns:a16="http://schemas.microsoft.com/office/drawing/2014/main" id="{498DF68F-B551-4439-8D83-0651358D5476}"/>
                  </a:ext>
                </a:extLst>
              </p:cNvPr>
              <p:cNvSpPr txBox="1"/>
              <p:nvPr/>
            </p:nvSpPr>
            <p:spPr>
              <a:xfrm>
                <a:off x="7194372" y="4122041"/>
                <a:ext cx="396240" cy="3320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BR" sz="1200" b="1" dirty="0">
                    <a:solidFill>
                      <a:srgbClr val="FF0000"/>
                    </a:solidFill>
                  </a:rPr>
                  <a:t>*</a:t>
                </a:r>
              </a:p>
            </p:txBody>
          </p:sp>
        </p:grpSp>
      </p:grpSp>
      <p:sp>
        <p:nvSpPr>
          <p:cNvPr id="29" name="CaixaDeTexto 28">
            <a:extLst>
              <a:ext uri="{FF2B5EF4-FFF2-40B4-BE49-F238E27FC236}">
                <a16:creationId xmlns:a16="http://schemas.microsoft.com/office/drawing/2014/main" id="{76CF126B-0B67-4A8C-9FA3-DCC361EF1397}"/>
              </a:ext>
            </a:extLst>
          </p:cNvPr>
          <p:cNvSpPr txBox="1"/>
          <p:nvPr/>
        </p:nvSpPr>
        <p:spPr>
          <a:xfrm>
            <a:off x="1898313" y="12663074"/>
            <a:ext cx="7090594" cy="24622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b="1" dirty="0"/>
              <a:t>Reactivity of chromatographic fractions of venom pools from </a:t>
            </a:r>
            <a:r>
              <a:rPr lang="en-US" sz="1400" b="1" i="1" dirty="0"/>
              <a:t>B. </a:t>
            </a:r>
            <a:r>
              <a:rPr lang="en-US" sz="1400" b="1" i="1" dirty="0" err="1"/>
              <a:t>atrox</a:t>
            </a:r>
            <a:r>
              <a:rPr lang="en-US" sz="1400" b="1" i="1" dirty="0"/>
              <a:t> </a:t>
            </a:r>
            <a:r>
              <a:rPr lang="en-US" sz="1400" b="1" dirty="0"/>
              <a:t>with the commercial </a:t>
            </a:r>
            <a:r>
              <a:rPr lang="en-US" sz="1400" b="1" dirty="0" err="1"/>
              <a:t>Bothrops</a:t>
            </a:r>
            <a:r>
              <a:rPr lang="en-US" sz="1400" b="1" dirty="0"/>
              <a:t> Antivenom in comparison with a species-specific antiserum</a:t>
            </a:r>
            <a:r>
              <a:rPr lang="pt-BR" sz="1400" dirty="0"/>
              <a:t>. </a:t>
            </a:r>
            <a:r>
              <a:rPr lang="en-US" sz="1400" dirty="0"/>
              <a:t>Individual venoms obtained from 37 adult specimens of </a:t>
            </a:r>
            <a:r>
              <a:rPr lang="en-US" sz="1400" i="1" dirty="0"/>
              <a:t>B. </a:t>
            </a:r>
            <a:r>
              <a:rPr lang="en-US" sz="1400" i="1" dirty="0" err="1"/>
              <a:t>atrox</a:t>
            </a:r>
            <a:r>
              <a:rPr lang="en-US" sz="1400" i="1" dirty="0"/>
              <a:t> </a:t>
            </a:r>
            <a:r>
              <a:rPr lang="en-US" sz="1400" dirty="0"/>
              <a:t>were</a:t>
            </a:r>
            <a:r>
              <a:rPr lang="en-US" sz="1400" i="1" dirty="0"/>
              <a:t> </a:t>
            </a:r>
            <a:r>
              <a:rPr lang="en-US" sz="1400" dirty="0"/>
              <a:t>grouped in four pools of venom according to four habitats (forest = 10, pasture = 10, floodplain = 9, and degraded area = 8) located at west of Pará State – Brazil and fractioned by high-performance liquid chromatography (Chromatograms) using a C-18 column. The chromatographic fractions of the venoms were collected and then assayed by ELISA to evaluate its reactivity with two different antivenoms: SAB – Commercial </a:t>
            </a:r>
            <a:r>
              <a:rPr lang="en-US" sz="1400" dirty="0" err="1"/>
              <a:t>Bothrops</a:t>
            </a:r>
            <a:r>
              <a:rPr lang="en-US" sz="1400" dirty="0"/>
              <a:t> Antivenom; and Anti-ATX – a polyclonal antibody produced in rabbits against the </a:t>
            </a:r>
            <a:r>
              <a:rPr lang="en-US" sz="1400" i="1" dirty="0"/>
              <a:t>B. </a:t>
            </a:r>
            <a:r>
              <a:rPr lang="en-US" sz="1400" i="1" dirty="0" err="1"/>
              <a:t>atrox</a:t>
            </a:r>
            <a:r>
              <a:rPr lang="en-US" sz="1400" i="1" dirty="0"/>
              <a:t> </a:t>
            </a:r>
            <a:r>
              <a:rPr lang="en-US" sz="1400" dirty="0"/>
              <a:t>venom. Red asterisks indicate the chromatographic fractions from which were isolated the PLA</a:t>
            </a:r>
            <a:r>
              <a:rPr lang="en-US" sz="1400" baseline="-25000" dirty="0"/>
              <a:t>2</a:t>
            </a:r>
            <a:r>
              <a:rPr lang="en-US" sz="1400" dirty="0"/>
              <a:t>s analyzed in this work: fraction 3 = FA1, fraction 8 = FA3, and fraction 9 = FA4.</a:t>
            </a:r>
            <a:endParaRPr lang="pt-BR" sz="1400" dirty="0"/>
          </a:p>
        </p:txBody>
      </p:sp>
      <p:sp>
        <p:nvSpPr>
          <p:cNvPr id="30" name="CaixaDeTexto 29">
            <a:extLst>
              <a:ext uri="{FF2B5EF4-FFF2-40B4-BE49-F238E27FC236}">
                <a16:creationId xmlns:a16="http://schemas.microsoft.com/office/drawing/2014/main" id="{84694234-3316-6CAB-0C4E-EB63668CFD9E}"/>
              </a:ext>
            </a:extLst>
          </p:cNvPr>
          <p:cNvSpPr txBox="1"/>
          <p:nvPr/>
        </p:nvSpPr>
        <p:spPr>
          <a:xfrm>
            <a:off x="757183" y="1290858"/>
            <a:ext cx="922902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600" b="1" dirty="0">
                <a:cs typeface="Arial" panose="020B0604020202020204" pitchFamily="34" charset="0"/>
              </a:rPr>
              <a:t>Figure S1. </a:t>
            </a:r>
            <a:r>
              <a:rPr lang="en-US" sz="16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Calibri" panose="020F0502020204030204" pitchFamily="34" charset="0"/>
              </a:rPr>
              <a:t>Reactivity of chromatographic fractions from </a:t>
            </a:r>
            <a:r>
              <a:rPr lang="en-US" sz="1600" i="1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Calibri" panose="020F0502020204030204" pitchFamily="34" charset="0"/>
              </a:rPr>
              <a:t>B. atrox </a:t>
            </a:r>
            <a:r>
              <a:rPr lang="en-US" sz="16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Calibri" panose="020F0502020204030204" pitchFamily="34" charset="0"/>
              </a:rPr>
              <a:t>venom with the commercial </a:t>
            </a:r>
            <a:r>
              <a:rPr lang="en-US" sz="1600" i="1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Calibri" panose="020F0502020204030204" pitchFamily="34" charset="0"/>
              </a:rPr>
              <a:t>Bothrops</a:t>
            </a:r>
            <a:r>
              <a:rPr lang="en-US" sz="16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Calibri" panose="020F0502020204030204" pitchFamily="34" charset="0"/>
              </a:rPr>
              <a:t> Antivenom in comparison with a species-specific antiserum</a:t>
            </a:r>
            <a:endParaRPr lang="pt-BR" sz="16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1578288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Escritório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162</TotalTime>
  <Words>199</Words>
  <Application>Microsoft Office PowerPoint</Application>
  <PresentationFormat>Custom</PresentationFormat>
  <Paragraphs>1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o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Emília Aguiar</dc:creator>
  <cp:lastModifiedBy>MDPI-76</cp:lastModifiedBy>
  <cp:revision>496</cp:revision>
  <dcterms:created xsi:type="dcterms:W3CDTF">2020-09-01T21:51:56Z</dcterms:created>
  <dcterms:modified xsi:type="dcterms:W3CDTF">2022-08-08T14:11:58Z</dcterms:modified>
</cp:coreProperties>
</file>